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94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49318C-DB24-4B90-84EA-CB8635A34647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F6221A-0E01-4B01-AA54-E931BF7E0F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742672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F6221A-0E01-4B01-AA54-E931BF7E0FB0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27161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3CFB1-E0ED-58F2-61C3-AA5D0D4329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4A71FA9-71A6-1180-65B2-868EAD50D4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C6566C-7196-BE6B-8BAE-A137D2783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0A0924-B1A8-154D-2376-6138BD4B34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2EBF3F-3D3A-6A63-2001-7B8D47336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6133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1E3D9C-D4BE-C8E8-69B4-4351F8E6BF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36E07F8-2DD1-6C1E-7FCA-91241B91FA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8162CA-CE43-224C-7C95-F37506114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B2CABD-CED8-0AFA-B95F-9482A2C9D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6908D8-C068-6125-9AD1-13E38D066E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79506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950A985-6E97-C335-3690-47685B97E7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7CB43F-3ECC-6E06-38AE-FEE4DEAC90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1623ED-1595-A32B-3137-271D8C253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6D2A11-84CF-A9BF-26C3-477AA1B23D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B37A20-F56E-EDFA-7FC0-A28F52D88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15991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76CA37-1379-69FE-BCBA-8DE8D3172C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923F1D-CA53-F4E1-DFA6-E0A976D052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2083F6-8B19-14B5-1177-10868BBC9E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C9D7DD-809A-6F8E-3F85-446AB2749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A2060A-3A67-5454-22C9-CC3EC8645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96357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41D6D0-A904-BC75-29E5-5E1B331960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55EA75-A2C2-C991-B0B7-ABF00873FE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632FA6-396F-8DAB-E6DA-A3764FBC6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4D1C84-389A-18C6-ADB8-6FA54F6F7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D6FEE3-F9E1-7E11-877B-2D293C58B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69919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F0333-791C-C484-0203-EC051E4608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AB20C0-01A3-D535-AA2D-D0DA19ED0A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160E08-65FF-83A5-17A9-4A12BFBDD9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8220F2-0CEE-B918-59B7-29EE5184FE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D6F356-D51B-D2D0-AA48-7169348FE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C2E382-DBF5-68C6-5D6C-43F90DECA6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5208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9D289F-DF5A-1DB7-BF35-9E8B5DCDE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A02F8A-D137-159B-B638-32C2D524D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395F2D-5559-2E87-17FD-405D2860DD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F222396-205E-F675-8EBD-95FCDAD3EF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EF9F46C-2426-8F50-D3C7-26DF164424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445F3E-A762-57E3-ABB7-5E05220B0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AF78A8-D119-2083-20D2-F08402933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55EF1A-8D7D-8A86-4824-FB562826E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0009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02A003-D624-7297-B6A3-3E37B4607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65383A-D219-CCF2-7C9D-EFB71048F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381C34-F0FE-F1EE-9EC1-36306AA3E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90518A-5D93-998F-E495-0A31E61F2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2782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317197-8B46-CFD0-FA3B-1925175C2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EDC6D0-0DB2-AF1E-E2BE-10C7886B5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10F9B4-D352-1D8D-CFEB-2A640230A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26854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CB0B9C-CA67-BDA7-DCD5-21D541DA53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79449C-D336-D0AD-34BA-EC85CAA956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941638-B8E1-DE59-A54F-C13987B0AD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134B26-A78F-868B-5008-B41C10472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FFE593-2476-05E4-1C9A-343E6A503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109485-D860-16F6-8907-A98501382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30784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36A279-C802-8B4C-2C63-B5E837FF66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539E74-4FBF-C7C8-6551-89CF3B0983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C17ECC-6468-2225-09AF-3BE6FD6E3F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D314C3-0B04-53F5-30DA-71FB0458F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0C545F-C63E-F7CC-B351-54813542A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03A43E-74F2-E8BF-801F-FE85CF1E3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72489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124A1D-9A41-F195-E231-DBC5D229B7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E48667-574C-DE0F-1602-B4CD144406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9A3A0C-4ED5-0720-8F70-D203A1691B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F71BF3-87AE-4A98-9CD5-B515810CD159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B40352-A5CA-6A68-E496-766294E4F8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C9100E-573C-8C9F-A853-D71396E668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155DF-2AD2-47B0-8A69-5FE9598EF04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49729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6E056F2D-875A-D81F-E123-81A7A4806EBE}"/>
              </a:ext>
            </a:extLst>
          </p:cNvPr>
          <p:cNvGrpSpPr/>
          <p:nvPr/>
        </p:nvGrpSpPr>
        <p:grpSpPr>
          <a:xfrm>
            <a:off x="1915885" y="576942"/>
            <a:ext cx="7527239" cy="4604655"/>
            <a:chOff x="1066798" y="630690"/>
            <a:chExt cx="9813241" cy="6151108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1A702F89-8CC1-E47B-8461-0CD108395957}"/>
                </a:ext>
              </a:extLst>
            </p:cNvPr>
            <p:cNvGrpSpPr/>
            <p:nvPr/>
          </p:nvGrpSpPr>
          <p:grpSpPr>
            <a:xfrm>
              <a:off x="3397429" y="3732437"/>
              <a:ext cx="4878978" cy="3049361"/>
              <a:chOff x="3397429" y="3732437"/>
              <a:chExt cx="4878978" cy="3049361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6017F338-63E7-9471-86A4-573E9482EA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397429" y="3732437"/>
                <a:ext cx="4878978" cy="3049361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56AB8AD-2368-8D2E-F31A-BB737F5780C3}"/>
                  </a:ext>
                </a:extLst>
              </p:cNvPr>
              <p:cNvSpPr txBox="1"/>
              <p:nvPr/>
            </p:nvSpPr>
            <p:spPr>
              <a:xfrm>
                <a:off x="3397429" y="3887884"/>
                <a:ext cx="14190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400" dirty="0">
                    <a:solidFill>
                      <a:schemeClr val="bg1"/>
                    </a:solidFill>
                  </a:rPr>
                  <a:t>GXM + DAPI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6B330B8-E5E3-E58A-6525-9AFABC7D8E1A}"/>
                </a:ext>
              </a:extLst>
            </p:cNvPr>
            <p:cNvGrpSpPr/>
            <p:nvPr/>
          </p:nvGrpSpPr>
          <p:grpSpPr>
            <a:xfrm>
              <a:off x="6001061" y="630690"/>
              <a:ext cx="4878978" cy="3049361"/>
              <a:chOff x="6094910" y="630690"/>
              <a:chExt cx="4878978" cy="3049361"/>
            </a:xfrm>
          </p:grpSpPr>
          <p:pic>
            <p:nvPicPr>
              <p:cNvPr id="5" name="Picture 4" descr="Green glowing spots on a black background&#10;&#10;Description automatically generated">
                <a:extLst>
                  <a:ext uri="{FF2B5EF4-FFF2-40B4-BE49-F238E27FC236}">
                    <a16:creationId xmlns:a16="http://schemas.microsoft.com/office/drawing/2014/main" id="{A00A91E6-6843-DB8D-F61D-7625F09237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094910" y="630690"/>
                <a:ext cx="4878978" cy="3049361"/>
              </a:xfrm>
              <a:prstGeom prst="rect">
                <a:avLst/>
              </a:prstGeom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1CDBD7D-A443-C626-0D68-7B468E8AE2A4}"/>
                  </a:ext>
                </a:extLst>
              </p:cNvPr>
              <p:cNvSpPr txBox="1"/>
              <p:nvPr/>
            </p:nvSpPr>
            <p:spPr>
              <a:xfrm>
                <a:off x="6094910" y="666519"/>
                <a:ext cx="14190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400" dirty="0">
                    <a:solidFill>
                      <a:schemeClr val="bg1"/>
                    </a:solidFill>
                  </a:rPr>
                  <a:t>GXM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8DDD44E8-A385-EA53-4F1C-7F8E091A5FE3}"/>
                </a:ext>
              </a:extLst>
            </p:cNvPr>
            <p:cNvGrpSpPr/>
            <p:nvPr/>
          </p:nvGrpSpPr>
          <p:grpSpPr>
            <a:xfrm>
              <a:off x="1066798" y="630690"/>
              <a:ext cx="4878978" cy="3049361"/>
              <a:chOff x="1066798" y="630690"/>
              <a:chExt cx="4878978" cy="3049361"/>
            </a:xfrm>
          </p:grpSpPr>
          <p:pic>
            <p:nvPicPr>
              <p:cNvPr id="7" name="Picture 6" descr="A blue blurry background&#10;&#10;Description automatically generated">
                <a:extLst>
                  <a:ext uri="{FF2B5EF4-FFF2-40B4-BE49-F238E27FC236}">
                    <a16:creationId xmlns:a16="http://schemas.microsoft.com/office/drawing/2014/main" id="{8E2FDD82-7349-CBEC-51F2-C00D57CA4D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066798" y="630690"/>
                <a:ext cx="4878978" cy="3049361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CF1CC164-7486-E004-0E6A-A9FD4B2C9124}"/>
                  </a:ext>
                </a:extLst>
              </p:cNvPr>
              <p:cNvSpPr txBox="1"/>
              <p:nvPr/>
            </p:nvSpPr>
            <p:spPr>
              <a:xfrm>
                <a:off x="1066798" y="691462"/>
                <a:ext cx="14190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400" dirty="0">
                    <a:solidFill>
                      <a:schemeClr val="bg1"/>
                    </a:solidFill>
                  </a:rPr>
                  <a:t>DAPI</a:t>
                </a:r>
              </a:p>
            </p:txBody>
          </p:sp>
        </p:grp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DD02E00A-9DD0-8810-4B4A-C86D88DE9158}"/>
              </a:ext>
            </a:extLst>
          </p:cNvPr>
          <p:cNvSpPr txBox="1"/>
          <p:nvPr/>
        </p:nvSpPr>
        <p:spPr>
          <a:xfrm>
            <a:off x="740227" y="5544918"/>
            <a:ext cx="11201401" cy="9682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IN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: Day 60 cerebral organoids demonstrating distribution of GXM. </a:t>
            </a:r>
            <a:r>
              <a:rPr lang="en-IN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ay 60 cerebral organoids exposed to 50µg/mL GXM for 48 hours, demonstrating the distribution of GXM throughout them.  Anti-GXM antibody (green), DAPI (blue), and merged image showing cerebral organoids positive for Anti-GXM antibody and DAPI. </a:t>
            </a:r>
            <a:endParaRPr lang="en-IN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328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3</TotalTime>
  <Words>62</Words>
  <Application>Microsoft Office PowerPoint</Application>
  <PresentationFormat>Widescreen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esh Upadhya [MAHE-KMC]</dc:creator>
  <cp:lastModifiedBy>Dinesh Upadhya [MAHE-KMC]</cp:lastModifiedBy>
  <cp:revision>71</cp:revision>
  <dcterms:created xsi:type="dcterms:W3CDTF">2023-06-03T06:23:44Z</dcterms:created>
  <dcterms:modified xsi:type="dcterms:W3CDTF">2025-10-30T05:51:15Z</dcterms:modified>
</cp:coreProperties>
</file>